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43E011-BCEF-4881-A5EE-F3D0035585C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0A8428-C776-4597-AB32-4B7E817F2A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86F669-E633-4748-AB55-B7B194C1B08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6F736E-8F30-450E-8C6E-1A80B7092F7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CD650A-BBC7-4723-B8EB-CBA8F0C177C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D210E2-27DF-4463-A822-EB9233E3A6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B72BFA-68FD-4AC6-8F74-14F5FBAA9B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CE5B85-50CE-41A3-A89E-F9E3E18D0B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E2FE11-3F0E-495F-B061-49C52F871F0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B9B88E-75DB-42E5-941F-3E216ECB04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33377D-7B9D-4049-9B17-4DC9A258CE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12CD2D-489F-4114-9BF0-5672BEBC0F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AU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AU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AU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C07ECBE-42BE-42B7-B006-BF26C5368672}" type="slidenum">
              <a:rPr b="0" lang="en-AU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415800" y="2232000"/>
          <a:ext cx="6172200" cy="2171880"/>
        </p:xfrm>
        <a:graphic>
          <a:graphicData uri="http://schemas.openxmlformats.org/drawingml/2006/table">
            <a:tbl>
              <a:tblPr/>
              <a:tblGrid>
                <a:gridCol w="368280"/>
                <a:gridCol w="2760840"/>
                <a:gridCol w="306360"/>
                <a:gridCol w="2736720"/>
              </a:tblGrid>
              <a:tr h="171360">
                <a:tc gridSpan="2"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59040" rIns="5904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9040" rIns="5904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4280">
                <a:tc>
                  <a:txBody>
                    <a:bodyPr lIns="59040" rIns="5904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9040" rIns="5904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arch term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9040" rIns="5904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9040" rIns="59040" tIns="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arch term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7560">
                <a:tc>
                  <a:txBody>
                    <a:bodyPr lIns="59040" rIns="59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njury (exploded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New Injury Severity Score or NISS).t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87200">
                <a:tc>
                  <a:txBody>
                    <a:bodyPr lIns="59040" rIns="59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rauma Severity Indices (exploded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Injury Severity Score or ISS).t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7200">
                <a:tc>
                  <a:txBody>
                    <a:bodyPr lIns="59040" rIns="59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nsitivity and specificity (exploded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#6 or #7 or #8 or #9 or #10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7560">
                <a:tc>
                  <a:txBody>
                    <a:bodyPr lIns="59040" rIns="59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edic*.t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mment.p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7200">
                <a:tc>
                  <a:txBody>
                    <a:bodyPr lIns="59040" rIns="59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#1 or #2 or #3 or #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etter.p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7560">
                <a:tc>
                  <a:txBody>
                    <a:bodyPr lIns="59040" rIns="59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Abbreviated Injury Scale or AIS).t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imit 1 to anim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7200">
                <a:tc>
                  <a:txBody>
                    <a:bodyPr lIns="59040" rIns="59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Trauma and Injury Severity Score or TRISS).t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#12 or #13 or #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7200">
                <a:tc>
                  <a:txBody>
                    <a:bodyPr lIns="59040" rIns="59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International classification of Disease* adj4 Injury Severity Score or ICISS).tw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#5 and #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7560">
                <a:tc>
                  <a:txBody>
                    <a:bodyPr lIns="59040" rIns="59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9040" rIns="5904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AU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#16 Not #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9040" marR="59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extBox 2"/>
          <p:cNvSpPr/>
          <p:nvPr/>
        </p:nvSpPr>
        <p:spPr>
          <a:xfrm>
            <a:off x="1089000" y="1450800"/>
            <a:ext cx="50767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earch words used to identify relevant articl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3-26T02:22:59Z</dcterms:created>
  <dc:creator>Hideo Tohira</dc:creator>
  <dc:description/>
  <dc:language>en-US</dc:language>
  <cp:lastModifiedBy>soba</cp:lastModifiedBy>
  <dcterms:modified xsi:type="dcterms:W3CDTF">2012-09-09T05:57:47Z</dcterms:modified>
  <cp:revision>3</cp:revision>
  <dc:subject/>
  <dc:title>Slide 1</dc:title>
</cp:coreProperties>
</file>